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77724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6197"/>
  </p:normalViewPr>
  <p:slideViewPr>
    <p:cSldViewPr snapToGrid="0" snapToObjects="1">
      <p:cViewPr varScale="1">
        <p:scale>
          <a:sx n="93" d="100"/>
          <a:sy n="93" d="100"/>
        </p:scale>
        <p:origin x="24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496484"/>
            <a:ext cx="6606540" cy="3183467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4802717"/>
            <a:ext cx="5829300" cy="2207683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644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137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486834"/>
            <a:ext cx="1675924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486834"/>
            <a:ext cx="4930616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972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318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279653"/>
            <a:ext cx="6703695" cy="3803649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119286"/>
            <a:ext cx="6703695" cy="2000249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795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4524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486836"/>
            <a:ext cx="670369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241551"/>
            <a:ext cx="3288089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340100"/>
            <a:ext cx="3288089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241551"/>
            <a:ext cx="3304282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340100"/>
            <a:ext cx="3304282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4366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873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51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316569"/>
            <a:ext cx="3934778" cy="6498167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481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316569"/>
            <a:ext cx="3934778" cy="6498167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393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486836"/>
            <a:ext cx="670369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434167"/>
            <a:ext cx="670369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905F52-124A-B64A-916C-91118AF90BD0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8475136"/>
            <a:ext cx="262318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279D5-2C82-4A44-8F1A-CAEEF31DD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805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>
            <a:extLst>
              <a:ext uri="{FF2B5EF4-FFF2-40B4-BE49-F238E27FC236}">
                <a16:creationId xmlns:a16="http://schemas.microsoft.com/office/drawing/2014/main" id="{D438A628-B512-0A4E-8834-743ACB6A843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1095" y="661448"/>
            <a:ext cx="7250210" cy="43359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DB998472-4F8F-274F-9C92-85EEBC6F064A}"/>
              </a:ext>
            </a:extLst>
          </p:cNvPr>
          <p:cNvSpPr/>
          <p:nvPr/>
        </p:nvSpPr>
        <p:spPr>
          <a:xfrm>
            <a:off x="261095" y="5148076"/>
            <a:ext cx="725021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</a:rPr>
              <a:t>Supplementary figure 2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</a:rPr>
              <a:t>: Tumor cells were observed to completely obstruct the cerebral aqueduct in (57%) 4/7 of mice with H&amp;E from the 100,000 DF-1 cell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</a:rPr>
              <a:t>intrapontine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</a:rPr>
              <a:t> injection cohort 3 weeks post-injection. Black arrow indicates the cerebral aqueduct. (4x magnification, scalebar = 500 </a:t>
            </a:r>
            <a:r>
              <a:rPr lang="el-GR" sz="1100" dirty="0">
                <a:solidFill>
                  <a:srgbClr val="202124"/>
                </a:solidFill>
                <a:latin typeface="Arial" panose="020B0604020202020204" pitchFamily="34" charset="0"/>
              </a:rPr>
              <a:t>μ</a:t>
            </a:r>
            <a:r>
              <a:rPr lang="en-US" sz="1100" dirty="0">
                <a:solidFill>
                  <a:srgbClr val="202124"/>
                </a:solidFill>
                <a:latin typeface="Arial" panose="020B0604020202020204" pitchFamily="34" charset="0"/>
              </a:rPr>
              <a:t>m) 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7297673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54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Shelei</dc:creator>
  <cp:lastModifiedBy>Pan, Shelei</cp:lastModifiedBy>
  <cp:revision>1</cp:revision>
  <dcterms:created xsi:type="dcterms:W3CDTF">2022-02-21T16:42:06Z</dcterms:created>
  <dcterms:modified xsi:type="dcterms:W3CDTF">2022-02-21T16:43:27Z</dcterms:modified>
</cp:coreProperties>
</file>